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4607560" cy="233997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76496" y="383654"/>
            <a:ext cx="3458980" cy="816147"/>
          </a:xfrm>
        </p:spPr>
        <p:txBody>
          <a:bodyPr anchor="b"/>
          <a:lstStyle>
            <a:lvl1pPr algn="ctr">
              <a:defRPr sz="204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576496" y="1231276"/>
            <a:ext cx="3458980" cy="565985"/>
          </a:xfrm>
        </p:spPr>
        <p:txBody>
          <a:bodyPr/>
          <a:lstStyle>
            <a:lvl1pPr marL="0" indent="0" algn="ctr">
              <a:buNone/>
              <a:defRPr sz="825"/>
            </a:lvl1pPr>
            <a:lvl2pPr marL="156845" indent="0" algn="ctr">
              <a:buNone/>
              <a:defRPr sz="670"/>
            </a:lvl2pPr>
            <a:lvl3pPr marL="312420" indent="0" algn="ctr">
              <a:buNone/>
              <a:defRPr sz="605"/>
            </a:lvl3pPr>
            <a:lvl4pPr marL="469265" indent="0" algn="ctr">
              <a:buNone/>
              <a:defRPr sz="550"/>
            </a:lvl4pPr>
            <a:lvl5pPr marL="626110" indent="0" algn="ctr">
              <a:buNone/>
              <a:defRPr sz="550"/>
            </a:lvl5pPr>
            <a:lvl6pPr marL="781685" indent="0" algn="ctr">
              <a:buNone/>
              <a:defRPr sz="550"/>
            </a:lvl6pPr>
            <a:lvl7pPr marL="936625" indent="0" algn="ctr">
              <a:buNone/>
              <a:defRPr sz="550"/>
            </a:lvl7pPr>
            <a:lvl8pPr marL="1092835" indent="0" algn="ctr">
              <a:buNone/>
              <a:defRPr sz="550"/>
            </a:lvl8pPr>
            <a:lvl9pPr marL="1248410" indent="0" algn="ctr">
              <a:buNone/>
              <a:defRPr sz="55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300444" y="124810"/>
            <a:ext cx="994455" cy="198664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17073" y="124810"/>
            <a:ext cx="2925720" cy="198664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14671" y="584435"/>
            <a:ext cx="3977826" cy="975144"/>
          </a:xfrm>
        </p:spPr>
        <p:txBody>
          <a:bodyPr anchor="b"/>
          <a:lstStyle>
            <a:lvl1pPr>
              <a:defRPr sz="204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14671" y="1568804"/>
            <a:ext cx="3977826" cy="512805"/>
          </a:xfrm>
        </p:spPr>
        <p:txBody>
          <a:bodyPr/>
          <a:lstStyle>
            <a:lvl1pPr marL="0" indent="0">
              <a:buNone/>
              <a:defRPr sz="825">
                <a:solidFill>
                  <a:schemeClr val="tx1">
                    <a:tint val="75000"/>
                  </a:schemeClr>
                </a:solidFill>
              </a:defRPr>
            </a:lvl1pPr>
            <a:lvl2pPr marL="156845" indent="0">
              <a:buNone/>
              <a:defRPr sz="670">
                <a:solidFill>
                  <a:schemeClr val="tx1">
                    <a:tint val="75000"/>
                  </a:schemeClr>
                </a:solidFill>
              </a:defRPr>
            </a:lvl2pPr>
            <a:lvl3pPr marL="312420" indent="0">
              <a:buNone/>
              <a:defRPr sz="605">
                <a:solidFill>
                  <a:schemeClr val="tx1">
                    <a:tint val="75000"/>
                  </a:schemeClr>
                </a:solidFill>
              </a:defRPr>
            </a:lvl3pPr>
            <a:lvl4pPr marL="469265" indent="0">
              <a:buNone/>
              <a:defRPr sz="550">
                <a:solidFill>
                  <a:schemeClr val="tx1">
                    <a:tint val="75000"/>
                  </a:schemeClr>
                </a:solidFill>
              </a:defRPr>
            </a:lvl4pPr>
            <a:lvl5pPr marL="626110" indent="0">
              <a:buNone/>
              <a:defRPr sz="550">
                <a:solidFill>
                  <a:schemeClr val="tx1">
                    <a:tint val="75000"/>
                  </a:schemeClr>
                </a:solidFill>
              </a:defRPr>
            </a:lvl5pPr>
            <a:lvl6pPr marL="781685" indent="0">
              <a:buNone/>
              <a:defRPr sz="550">
                <a:solidFill>
                  <a:schemeClr val="tx1">
                    <a:tint val="75000"/>
                  </a:schemeClr>
                </a:solidFill>
              </a:defRPr>
            </a:lvl6pPr>
            <a:lvl7pPr marL="936625" indent="0">
              <a:buNone/>
              <a:defRPr sz="550">
                <a:solidFill>
                  <a:schemeClr val="tx1">
                    <a:tint val="75000"/>
                  </a:schemeClr>
                </a:solidFill>
              </a:defRPr>
            </a:lvl7pPr>
            <a:lvl8pPr marL="1092835" indent="0">
              <a:buNone/>
              <a:defRPr sz="550">
                <a:solidFill>
                  <a:schemeClr val="tx1">
                    <a:tint val="75000"/>
                  </a:schemeClr>
                </a:solidFill>
              </a:defRPr>
            </a:lvl8pPr>
            <a:lvl9pPr marL="1248410" indent="0">
              <a:buNone/>
              <a:defRPr sz="5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17073" y="624049"/>
            <a:ext cx="1960088" cy="1487407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334811" y="624049"/>
            <a:ext cx="1960088" cy="1487407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17673" y="124810"/>
            <a:ext cx="3977826" cy="45311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17673" y="574668"/>
            <a:ext cx="1951080" cy="281637"/>
          </a:xfrm>
        </p:spPr>
        <p:txBody>
          <a:bodyPr anchor="b"/>
          <a:lstStyle>
            <a:lvl1pPr marL="0" indent="0">
              <a:buNone/>
              <a:defRPr sz="825" b="1"/>
            </a:lvl1pPr>
            <a:lvl2pPr marL="156845" indent="0">
              <a:buNone/>
              <a:defRPr sz="670" b="1"/>
            </a:lvl2pPr>
            <a:lvl3pPr marL="312420" indent="0">
              <a:buNone/>
              <a:defRPr sz="605" b="1"/>
            </a:lvl3pPr>
            <a:lvl4pPr marL="469265" indent="0">
              <a:buNone/>
              <a:defRPr sz="550" b="1"/>
            </a:lvl4pPr>
            <a:lvl5pPr marL="626110" indent="0">
              <a:buNone/>
              <a:defRPr sz="550" b="1"/>
            </a:lvl5pPr>
            <a:lvl6pPr marL="781685" indent="0">
              <a:buNone/>
              <a:defRPr sz="550" b="1"/>
            </a:lvl6pPr>
            <a:lvl7pPr marL="936625" indent="0">
              <a:buNone/>
              <a:defRPr sz="550" b="1"/>
            </a:lvl7pPr>
            <a:lvl8pPr marL="1092835" indent="0">
              <a:buNone/>
              <a:defRPr sz="550" b="1"/>
            </a:lvl8pPr>
            <a:lvl9pPr marL="1248410" indent="0">
              <a:buNone/>
              <a:defRPr sz="55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17673" y="856303"/>
            <a:ext cx="1951080" cy="125949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2334811" y="574668"/>
            <a:ext cx="1960689" cy="281637"/>
          </a:xfrm>
        </p:spPr>
        <p:txBody>
          <a:bodyPr anchor="b"/>
          <a:lstStyle>
            <a:lvl1pPr marL="0" indent="0">
              <a:buNone/>
              <a:defRPr sz="825" b="1"/>
            </a:lvl1pPr>
            <a:lvl2pPr marL="156845" indent="0">
              <a:buNone/>
              <a:defRPr sz="670" b="1"/>
            </a:lvl2pPr>
            <a:lvl3pPr marL="312420" indent="0">
              <a:buNone/>
              <a:defRPr sz="605" b="1"/>
            </a:lvl3pPr>
            <a:lvl4pPr marL="469265" indent="0">
              <a:buNone/>
              <a:defRPr sz="550" b="1"/>
            </a:lvl4pPr>
            <a:lvl5pPr marL="626110" indent="0">
              <a:buNone/>
              <a:defRPr sz="550" b="1"/>
            </a:lvl5pPr>
            <a:lvl6pPr marL="781685" indent="0">
              <a:buNone/>
              <a:defRPr sz="550" b="1"/>
            </a:lvl6pPr>
            <a:lvl7pPr marL="936625" indent="0">
              <a:buNone/>
              <a:defRPr sz="550" b="1"/>
            </a:lvl7pPr>
            <a:lvl8pPr marL="1092835" indent="0">
              <a:buNone/>
              <a:defRPr sz="550" b="1"/>
            </a:lvl8pPr>
            <a:lvl9pPr marL="1248410" indent="0">
              <a:buNone/>
              <a:defRPr sz="55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2334811" y="856303"/>
            <a:ext cx="1960689" cy="125949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17673" y="156284"/>
            <a:ext cx="1487481" cy="546992"/>
          </a:xfrm>
        </p:spPr>
        <p:txBody>
          <a:bodyPr anchor="b"/>
          <a:lstStyle>
            <a:lvl1pPr>
              <a:defRPr sz="109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1960689" y="337529"/>
            <a:ext cx="2334811" cy="1665939"/>
          </a:xfrm>
        </p:spPr>
        <p:txBody>
          <a:bodyPr/>
          <a:lstStyle>
            <a:lvl1pPr>
              <a:defRPr sz="1090"/>
            </a:lvl1pPr>
            <a:lvl2pPr>
              <a:defRPr sz="960"/>
            </a:lvl2pPr>
            <a:lvl3pPr>
              <a:defRPr sz="825"/>
            </a:lvl3pPr>
            <a:lvl4pPr>
              <a:defRPr sz="670"/>
            </a:lvl4pPr>
            <a:lvl5pPr>
              <a:defRPr sz="670"/>
            </a:lvl5pPr>
            <a:lvl6pPr>
              <a:defRPr sz="670"/>
            </a:lvl6pPr>
            <a:lvl7pPr>
              <a:defRPr sz="670"/>
            </a:lvl7pPr>
            <a:lvl8pPr>
              <a:defRPr sz="670"/>
            </a:lvl8pPr>
            <a:lvl9pPr>
              <a:defRPr sz="67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17673" y="703276"/>
            <a:ext cx="1487481" cy="1302905"/>
          </a:xfrm>
        </p:spPr>
        <p:txBody>
          <a:bodyPr/>
          <a:lstStyle>
            <a:lvl1pPr marL="0" indent="0">
              <a:buNone/>
              <a:defRPr sz="550"/>
            </a:lvl1pPr>
            <a:lvl2pPr marL="156845" indent="0">
              <a:buNone/>
              <a:defRPr sz="475"/>
            </a:lvl2pPr>
            <a:lvl3pPr marL="312420" indent="0">
              <a:buNone/>
              <a:defRPr sz="410"/>
            </a:lvl3pPr>
            <a:lvl4pPr marL="469265" indent="0">
              <a:buNone/>
              <a:defRPr sz="355"/>
            </a:lvl4pPr>
            <a:lvl5pPr marL="626110" indent="0">
              <a:buNone/>
              <a:defRPr sz="355"/>
            </a:lvl5pPr>
            <a:lvl6pPr marL="781685" indent="0">
              <a:buNone/>
              <a:defRPr sz="355"/>
            </a:lvl6pPr>
            <a:lvl7pPr marL="936625" indent="0">
              <a:buNone/>
              <a:defRPr sz="355"/>
            </a:lvl7pPr>
            <a:lvl8pPr marL="1092835" indent="0">
              <a:buNone/>
              <a:defRPr sz="355"/>
            </a:lvl8pPr>
            <a:lvl9pPr marL="1248410" indent="0">
              <a:buNone/>
              <a:defRPr sz="35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17673" y="156284"/>
            <a:ext cx="1487481" cy="546992"/>
          </a:xfrm>
        </p:spPr>
        <p:txBody>
          <a:bodyPr anchor="b"/>
          <a:lstStyle>
            <a:lvl1pPr>
              <a:defRPr sz="109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960689" y="337529"/>
            <a:ext cx="2334811" cy="1665939"/>
          </a:xfrm>
        </p:spPr>
        <p:txBody>
          <a:bodyPr/>
          <a:lstStyle>
            <a:lvl1pPr marL="0" indent="0">
              <a:buNone/>
              <a:defRPr sz="1090"/>
            </a:lvl1pPr>
            <a:lvl2pPr marL="156845" indent="0">
              <a:buNone/>
              <a:defRPr sz="960"/>
            </a:lvl2pPr>
            <a:lvl3pPr marL="312420" indent="0">
              <a:buNone/>
              <a:defRPr sz="825"/>
            </a:lvl3pPr>
            <a:lvl4pPr marL="469265" indent="0">
              <a:buNone/>
              <a:defRPr sz="670"/>
            </a:lvl4pPr>
            <a:lvl5pPr marL="626110" indent="0">
              <a:buNone/>
              <a:defRPr sz="670"/>
            </a:lvl5pPr>
            <a:lvl6pPr marL="781685" indent="0">
              <a:buNone/>
              <a:defRPr sz="670"/>
            </a:lvl6pPr>
            <a:lvl7pPr marL="936625" indent="0">
              <a:buNone/>
              <a:defRPr sz="670"/>
            </a:lvl7pPr>
            <a:lvl8pPr marL="1092835" indent="0">
              <a:buNone/>
              <a:defRPr sz="670"/>
            </a:lvl8pPr>
            <a:lvl9pPr marL="1248410" indent="0">
              <a:buNone/>
              <a:defRPr sz="67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17673" y="703276"/>
            <a:ext cx="1487481" cy="1302905"/>
          </a:xfrm>
        </p:spPr>
        <p:txBody>
          <a:bodyPr/>
          <a:lstStyle>
            <a:lvl1pPr marL="0" indent="0">
              <a:buNone/>
              <a:defRPr sz="550"/>
            </a:lvl1pPr>
            <a:lvl2pPr marL="156845" indent="0">
              <a:buNone/>
              <a:defRPr sz="475"/>
            </a:lvl2pPr>
            <a:lvl3pPr marL="312420" indent="0">
              <a:buNone/>
              <a:defRPr sz="410"/>
            </a:lvl3pPr>
            <a:lvl4pPr marL="469265" indent="0">
              <a:buNone/>
              <a:defRPr sz="355"/>
            </a:lvl4pPr>
            <a:lvl5pPr marL="626110" indent="0">
              <a:buNone/>
              <a:defRPr sz="355"/>
            </a:lvl5pPr>
            <a:lvl6pPr marL="781685" indent="0">
              <a:buNone/>
              <a:defRPr sz="355"/>
            </a:lvl6pPr>
            <a:lvl7pPr marL="936625" indent="0">
              <a:buNone/>
              <a:defRPr sz="355"/>
            </a:lvl7pPr>
            <a:lvl8pPr marL="1092835" indent="0">
              <a:buNone/>
              <a:defRPr sz="355"/>
            </a:lvl8pPr>
            <a:lvl9pPr marL="1248410" indent="0">
              <a:buNone/>
              <a:defRPr sz="35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17073" y="124810"/>
            <a:ext cx="3977826" cy="45311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17073" y="624049"/>
            <a:ext cx="3977826" cy="148740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17073" y="2172774"/>
            <a:ext cx="1037694" cy="1248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1527715" y="2172774"/>
            <a:ext cx="1556540" cy="1248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3257205" y="2172774"/>
            <a:ext cx="1037694" cy="1248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312420" rtl="0" eaLnBrk="1" latinLnBrk="0" hangingPunct="1">
        <a:lnSpc>
          <a:spcPct val="90000"/>
        </a:lnSpc>
        <a:spcBef>
          <a:spcPct val="0"/>
        </a:spcBef>
        <a:buNone/>
        <a:defRPr sz="15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6835" indent="-76835" algn="l" defTabSz="312420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1pPr>
      <a:lvl2pPr marL="233045" indent="-76835" algn="l" defTabSz="312420" rtl="0" eaLnBrk="1" latinLnBrk="0" hangingPunct="1">
        <a:lnSpc>
          <a:spcPct val="90000"/>
        </a:lnSpc>
        <a:spcBef>
          <a:spcPct val="33000"/>
        </a:spcBef>
        <a:buFont typeface="Arial" panose="020B0604020202020204" pitchFamily="34" charset="0"/>
        <a:buChar char="•"/>
        <a:defRPr sz="825" kern="1200">
          <a:solidFill>
            <a:schemeClr val="tx1"/>
          </a:solidFill>
          <a:latin typeface="+mn-lt"/>
          <a:ea typeface="+mn-ea"/>
          <a:cs typeface="+mn-cs"/>
        </a:defRPr>
      </a:lvl2pPr>
      <a:lvl3pPr marL="389890" indent="-76835" algn="l" defTabSz="312420" rtl="0" eaLnBrk="1" latinLnBrk="0" hangingPunct="1">
        <a:lnSpc>
          <a:spcPct val="90000"/>
        </a:lnSpc>
        <a:spcBef>
          <a:spcPct val="33000"/>
        </a:spcBef>
        <a:buFont typeface="Arial" panose="020B0604020202020204" pitchFamily="34" charset="0"/>
        <a:buChar char="•"/>
        <a:defRPr sz="670" kern="1200">
          <a:solidFill>
            <a:schemeClr val="tx1"/>
          </a:solidFill>
          <a:latin typeface="+mn-lt"/>
          <a:ea typeface="+mn-ea"/>
          <a:cs typeface="+mn-cs"/>
        </a:defRPr>
      </a:lvl3pPr>
      <a:lvl4pPr marL="548005" indent="-76835" algn="l" defTabSz="312420" rtl="0" eaLnBrk="1" latinLnBrk="0" hangingPunct="1">
        <a:lnSpc>
          <a:spcPct val="90000"/>
        </a:lnSpc>
        <a:spcBef>
          <a:spcPct val="33000"/>
        </a:spcBef>
        <a:buFont typeface="Arial" panose="020B0604020202020204" pitchFamily="34" charset="0"/>
        <a:buChar char="•"/>
        <a:defRPr sz="605" kern="1200">
          <a:solidFill>
            <a:schemeClr val="tx1"/>
          </a:solidFill>
          <a:latin typeface="+mn-lt"/>
          <a:ea typeface="+mn-ea"/>
          <a:cs typeface="+mn-cs"/>
        </a:defRPr>
      </a:lvl4pPr>
      <a:lvl5pPr marL="704850" indent="-76835" algn="l" defTabSz="312420" rtl="0" eaLnBrk="1" latinLnBrk="0" hangingPunct="1">
        <a:lnSpc>
          <a:spcPct val="90000"/>
        </a:lnSpc>
        <a:spcBef>
          <a:spcPct val="33000"/>
        </a:spcBef>
        <a:buFont typeface="Arial" panose="020B0604020202020204" pitchFamily="34" charset="0"/>
        <a:buChar char="•"/>
        <a:defRPr sz="605" kern="1200">
          <a:solidFill>
            <a:schemeClr val="tx1"/>
          </a:solidFill>
          <a:latin typeface="+mn-lt"/>
          <a:ea typeface="+mn-ea"/>
          <a:cs typeface="+mn-cs"/>
        </a:defRPr>
      </a:lvl5pPr>
      <a:lvl6pPr marL="859790" indent="-76835" algn="l" defTabSz="312420" rtl="0" eaLnBrk="1" latinLnBrk="0" hangingPunct="1">
        <a:lnSpc>
          <a:spcPct val="90000"/>
        </a:lnSpc>
        <a:spcBef>
          <a:spcPct val="33000"/>
        </a:spcBef>
        <a:buFont typeface="Arial" panose="020B0604020202020204" pitchFamily="34" charset="0"/>
        <a:buChar char="•"/>
        <a:defRPr sz="605" kern="1200">
          <a:solidFill>
            <a:schemeClr val="tx1"/>
          </a:solidFill>
          <a:latin typeface="+mn-lt"/>
          <a:ea typeface="+mn-ea"/>
          <a:cs typeface="+mn-cs"/>
        </a:defRPr>
      </a:lvl6pPr>
      <a:lvl7pPr marL="1016635" indent="-76835" algn="l" defTabSz="312420" rtl="0" eaLnBrk="1" latinLnBrk="0" hangingPunct="1">
        <a:lnSpc>
          <a:spcPct val="90000"/>
        </a:lnSpc>
        <a:spcBef>
          <a:spcPct val="33000"/>
        </a:spcBef>
        <a:buFont typeface="Arial" panose="020B0604020202020204" pitchFamily="34" charset="0"/>
        <a:buChar char="•"/>
        <a:defRPr sz="605" kern="1200">
          <a:solidFill>
            <a:schemeClr val="tx1"/>
          </a:solidFill>
          <a:latin typeface="+mn-lt"/>
          <a:ea typeface="+mn-ea"/>
          <a:cs typeface="+mn-cs"/>
        </a:defRPr>
      </a:lvl7pPr>
      <a:lvl8pPr marL="1171575" indent="-76835" algn="l" defTabSz="312420" rtl="0" eaLnBrk="1" latinLnBrk="0" hangingPunct="1">
        <a:lnSpc>
          <a:spcPct val="90000"/>
        </a:lnSpc>
        <a:spcBef>
          <a:spcPct val="33000"/>
        </a:spcBef>
        <a:buFont typeface="Arial" panose="020B0604020202020204" pitchFamily="34" charset="0"/>
        <a:buChar char="•"/>
        <a:defRPr sz="605" kern="1200">
          <a:solidFill>
            <a:schemeClr val="tx1"/>
          </a:solidFill>
          <a:latin typeface="+mn-lt"/>
          <a:ea typeface="+mn-ea"/>
          <a:cs typeface="+mn-cs"/>
        </a:defRPr>
      </a:lvl8pPr>
      <a:lvl9pPr marL="1327785" indent="-76835" algn="l" defTabSz="312420" rtl="0" eaLnBrk="1" latinLnBrk="0" hangingPunct="1">
        <a:lnSpc>
          <a:spcPct val="90000"/>
        </a:lnSpc>
        <a:spcBef>
          <a:spcPct val="33000"/>
        </a:spcBef>
        <a:buFont typeface="Arial" panose="020B0604020202020204" pitchFamily="34" charset="0"/>
        <a:buChar char="•"/>
        <a:defRPr sz="6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312420" rtl="0" eaLnBrk="1" latinLnBrk="0" hangingPunct="1">
        <a:defRPr sz="605" kern="1200">
          <a:solidFill>
            <a:schemeClr val="tx1"/>
          </a:solidFill>
          <a:latin typeface="+mn-lt"/>
          <a:ea typeface="+mn-ea"/>
          <a:cs typeface="+mn-cs"/>
        </a:defRPr>
      </a:lvl1pPr>
      <a:lvl2pPr marL="156845" algn="l" defTabSz="312420" rtl="0" eaLnBrk="1" latinLnBrk="0" hangingPunct="1">
        <a:defRPr sz="605" kern="1200">
          <a:solidFill>
            <a:schemeClr val="tx1"/>
          </a:solidFill>
          <a:latin typeface="+mn-lt"/>
          <a:ea typeface="+mn-ea"/>
          <a:cs typeface="+mn-cs"/>
        </a:defRPr>
      </a:lvl2pPr>
      <a:lvl3pPr marL="312420" algn="l" defTabSz="312420" rtl="0" eaLnBrk="1" latinLnBrk="0" hangingPunct="1">
        <a:defRPr sz="605" kern="1200">
          <a:solidFill>
            <a:schemeClr val="tx1"/>
          </a:solidFill>
          <a:latin typeface="+mn-lt"/>
          <a:ea typeface="+mn-ea"/>
          <a:cs typeface="+mn-cs"/>
        </a:defRPr>
      </a:lvl3pPr>
      <a:lvl4pPr marL="469265" algn="l" defTabSz="312420" rtl="0" eaLnBrk="1" latinLnBrk="0" hangingPunct="1">
        <a:defRPr sz="605" kern="1200">
          <a:solidFill>
            <a:schemeClr val="tx1"/>
          </a:solidFill>
          <a:latin typeface="+mn-lt"/>
          <a:ea typeface="+mn-ea"/>
          <a:cs typeface="+mn-cs"/>
        </a:defRPr>
      </a:lvl4pPr>
      <a:lvl5pPr marL="626110" algn="l" defTabSz="312420" rtl="0" eaLnBrk="1" latinLnBrk="0" hangingPunct="1">
        <a:defRPr sz="605" kern="1200">
          <a:solidFill>
            <a:schemeClr val="tx1"/>
          </a:solidFill>
          <a:latin typeface="+mn-lt"/>
          <a:ea typeface="+mn-ea"/>
          <a:cs typeface="+mn-cs"/>
        </a:defRPr>
      </a:lvl5pPr>
      <a:lvl6pPr marL="781685" algn="l" defTabSz="312420" rtl="0" eaLnBrk="1" latinLnBrk="0" hangingPunct="1">
        <a:defRPr sz="605" kern="1200">
          <a:solidFill>
            <a:schemeClr val="tx1"/>
          </a:solidFill>
          <a:latin typeface="+mn-lt"/>
          <a:ea typeface="+mn-ea"/>
          <a:cs typeface="+mn-cs"/>
        </a:defRPr>
      </a:lvl6pPr>
      <a:lvl7pPr marL="936625" algn="l" defTabSz="312420" rtl="0" eaLnBrk="1" latinLnBrk="0" hangingPunct="1">
        <a:defRPr sz="605" kern="1200">
          <a:solidFill>
            <a:schemeClr val="tx1"/>
          </a:solidFill>
          <a:latin typeface="+mn-lt"/>
          <a:ea typeface="+mn-ea"/>
          <a:cs typeface="+mn-cs"/>
        </a:defRPr>
      </a:lvl7pPr>
      <a:lvl8pPr marL="1092835" algn="l" defTabSz="312420" rtl="0" eaLnBrk="1" latinLnBrk="0" hangingPunct="1">
        <a:defRPr sz="605" kern="1200">
          <a:solidFill>
            <a:schemeClr val="tx1"/>
          </a:solidFill>
          <a:latin typeface="+mn-lt"/>
          <a:ea typeface="+mn-ea"/>
          <a:cs typeface="+mn-cs"/>
        </a:defRPr>
      </a:lvl8pPr>
      <a:lvl9pPr marL="1248410" algn="l" defTabSz="312420" rtl="0" eaLnBrk="1" latinLnBrk="0" hangingPunct="1">
        <a:defRPr sz="6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7.xml"/><Relationship Id="rId8" Type="http://schemas.openxmlformats.org/officeDocument/2006/relationships/tags" Target="../tags/tag6.xml"/><Relationship Id="rId7" Type="http://schemas.openxmlformats.org/officeDocument/2006/relationships/tags" Target="../tags/tag5.xml"/><Relationship Id="rId6" Type="http://schemas.openxmlformats.org/officeDocument/2006/relationships/tags" Target="../tags/tag4.xml"/><Relationship Id="rId5" Type="http://schemas.openxmlformats.org/officeDocument/2006/relationships/image" Target="../media/image2.tiff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2" Type="http://schemas.openxmlformats.org/officeDocument/2006/relationships/slideLayout" Target="../slideLayouts/slideLayout1.xml"/><Relationship Id="rId21" Type="http://schemas.openxmlformats.org/officeDocument/2006/relationships/tags" Target="../tags/tag17.xml"/><Relationship Id="rId20" Type="http://schemas.openxmlformats.org/officeDocument/2006/relationships/tags" Target="../tags/tag16.xml"/><Relationship Id="rId2" Type="http://schemas.openxmlformats.org/officeDocument/2006/relationships/image" Target="../media/image1.tiff"/><Relationship Id="rId19" Type="http://schemas.openxmlformats.org/officeDocument/2006/relationships/tags" Target="../tags/tag15.xml"/><Relationship Id="rId18" Type="http://schemas.openxmlformats.org/officeDocument/2006/relationships/tags" Target="../tags/tag14.xml"/><Relationship Id="rId17" Type="http://schemas.openxmlformats.org/officeDocument/2006/relationships/tags" Target="../tags/tag13.xml"/><Relationship Id="rId16" Type="http://schemas.openxmlformats.org/officeDocument/2006/relationships/tags" Target="../tags/tag12.xml"/><Relationship Id="rId15" Type="http://schemas.openxmlformats.org/officeDocument/2006/relationships/tags" Target="../tags/tag11.xml"/><Relationship Id="rId14" Type="http://schemas.openxmlformats.org/officeDocument/2006/relationships/image" Target="../media/image4.tiff"/><Relationship Id="rId13" Type="http://schemas.openxmlformats.org/officeDocument/2006/relationships/image" Target="../media/image3.tiff"/><Relationship Id="rId12" Type="http://schemas.openxmlformats.org/officeDocument/2006/relationships/tags" Target="../tags/tag10.xml"/><Relationship Id="rId11" Type="http://schemas.openxmlformats.org/officeDocument/2006/relationships/tags" Target="../tags/tag9.xml"/><Relationship Id="rId10" Type="http://schemas.openxmlformats.org/officeDocument/2006/relationships/tags" Target="../tags/tag8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8" name="组合 27"/>
          <p:cNvGrpSpPr/>
          <p:nvPr/>
        </p:nvGrpSpPr>
        <p:grpSpPr>
          <a:xfrm>
            <a:off x="-71957" y="-355648"/>
            <a:ext cx="2434188" cy="1909627"/>
            <a:chOff x="704" y="220"/>
            <a:chExt cx="3833" cy="3007"/>
          </a:xfrm>
        </p:grpSpPr>
        <p:pic>
          <p:nvPicPr>
            <p:cNvPr id="5" name="图片 4" descr="20250407  NC ENTV-1 JSRV-gag 2C3检"/>
            <p:cNvPicPr/>
            <p:nvPr>
              <p:custDataLst>
                <p:tags r:id="rId1"/>
              </p:custDataLst>
            </p:nvPr>
          </p:nvPicPr>
          <p:blipFill>
            <a:blip r:embed="rId2"/>
            <a:srcRect l="16913" t="20851" r="2559" b="65715"/>
            <a:stretch>
              <a:fillRect/>
            </a:stretch>
          </p:blipFill>
          <p:spPr>
            <a:xfrm>
              <a:off x="1696" y="1726"/>
              <a:ext cx="1669" cy="68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" name="文本框 15"/>
            <p:cNvSpPr txBox="1"/>
            <p:nvPr>
              <p:custDataLst>
                <p:tags r:id="rId3"/>
              </p:custDataLst>
            </p:nvPr>
          </p:nvSpPr>
          <p:spPr>
            <a:xfrm>
              <a:off x="1104" y="1894"/>
              <a:ext cx="905" cy="4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2C3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 rot="18780000">
              <a:off x="1722" y="1224"/>
              <a:ext cx="738" cy="39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 rot="18780000">
              <a:off x="2108" y="878"/>
              <a:ext cx="1770" cy="45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ENTV-1-Gag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 rot="18780000">
              <a:off x="2748" y="985"/>
              <a:ext cx="1396" cy="38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JSRV-Gag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图片 14" descr="20250407  NC ENTV-1 JSRV-gag 2C3检-actin"/>
            <p:cNvPicPr/>
            <p:nvPr>
              <p:custDataLst>
                <p:tags r:id="rId4"/>
              </p:custDataLst>
            </p:nvPr>
          </p:nvPicPr>
          <p:blipFill>
            <a:blip r:embed="rId5"/>
            <a:srcRect l="20200" t="38912" r="3172" b="47033"/>
            <a:stretch>
              <a:fillRect/>
            </a:stretch>
          </p:blipFill>
          <p:spPr>
            <a:xfrm>
              <a:off x="1703" y="2520"/>
              <a:ext cx="1661" cy="68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文本框 5"/>
            <p:cNvSpPr txBox="1"/>
            <p:nvPr>
              <p:custDataLst>
                <p:tags r:id="rId6"/>
              </p:custDataLst>
            </p:nvPr>
          </p:nvSpPr>
          <p:spPr>
            <a:xfrm>
              <a:off x="704" y="2636"/>
              <a:ext cx="1137" cy="4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anti-actin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9" name="组合 148"/>
            <p:cNvGrpSpPr/>
            <p:nvPr>
              <p:custDataLst>
                <p:tags r:id="rId7"/>
              </p:custDataLst>
            </p:nvPr>
          </p:nvGrpSpPr>
          <p:grpSpPr>
            <a:xfrm rot="0">
              <a:off x="3366" y="1597"/>
              <a:ext cx="1171" cy="488"/>
              <a:chOff x="2427" y="9008"/>
              <a:chExt cx="1171" cy="410"/>
            </a:xfrm>
          </p:grpSpPr>
          <p:cxnSp>
            <p:nvCxnSpPr>
              <p:cNvPr id="150" name="直接连接符 149"/>
              <p:cNvCxnSpPr/>
              <p:nvPr>
                <p:custDataLst>
                  <p:tags r:id="rId8"/>
                </p:custDataLst>
              </p:nvPr>
            </p:nvCxnSpPr>
            <p:spPr>
              <a:xfrm>
                <a:off x="2427" y="9170"/>
                <a:ext cx="19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sp>
            <p:nvSpPr>
              <p:cNvPr id="151" name="文本框 150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2541" y="9008"/>
                <a:ext cx="1057" cy="41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900">
                    <a:latin typeface="Arial" panose="020B0604020202020204" pitchFamily="34" charset="0"/>
                    <a:cs typeface="Arial" panose="020B0604020202020204" pitchFamily="34" charset="0"/>
                  </a:rPr>
                  <a:t>80KDa</a:t>
                </a:r>
                <a:endParaRPr lang="en-US" altLang="zh-C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组合 7"/>
            <p:cNvGrpSpPr/>
            <p:nvPr>
              <p:custDataLst>
                <p:tags r:id="rId10"/>
              </p:custDataLst>
            </p:nvPr>
          </p:nvGrpSpPr>
          <p:grpSpPr>
            <a:xfrm rot="0">
              <a:off x="3366" y="2817"/>
              <a:ext cx="1171" cy="410"/>
              <a:chOff x="2427" y="8980"/>
              <a:chExt cx="1171" cy="410"/>
            </a:xfrm>
          </p:grpSpPr>
          <p:cxnSp>
            <p:nvCxnSpPr>
              <p:cNvPr id="9" name="直接连接符 8"/>
              <p:cNvCxnSpPr/>
              <p:nvPr>
                <p:custDataLst>
                  <p:tags r:id="rId11"/>
                </p:custDataLst>
              </p:nvPr>
            </p:nvCxnSpPr>
            <p:spPr>
              <a:xfrm>
                <a:off x="2427" y="9170"/>
                <a:ext cx="19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sp>
            <p:nvSpPr>
              <p:cNvPr id="10" name="文本框 9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2541" y="8980"/>
                <a:ext cx="1057" cy="41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900">
                    <a:latin typeface="Arial" panose="020B0604020202020204" pitchFamily="34" charset="0"/>
                    <a:cs typeface="Arial" panose="020B0604020202020204" pitchFamily="34" charset="0"/>
                  </a:rPr>
                  <a:t>40KDa</a:t>
                </a:r>
                <a:endParaRPr lang="en-US" altLang="zh-C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9" name="组合 28"/>
          <p:cNvGrpSpPr/>
          <p:nvPr/>
        </p:nvGrpSpPr>
        <p:grpSpPr>
          <a:xfrm>
            <a:off x="2334260" y="-357505"/>
            <a:ext cx="2435225" cy="1918970"/>
            <a:chOff x="3676" y="-563"/>
            <a:chExt cx="3835" cy="3022"/>
          </a:xfrm>
        </p:grpSpPr>
        <p:pic>
          <p:nvPicPr>
            <p:cNvPr id="3" name="图片 2" descr="20250428 NC ENTV-1 JSRV pAb"/>
            <p:cNvPicPr>
              <a:picLocks noChangeAspect="1"/>
            </p:cNvPicPr>
            <p:nvPr/>
          </p:nvPicPr>
          <p:blipFill>
            <a:blip r:embed="rId13"/>
            <a:srcRect l="15269" t="12814" r="1247" b="76092"/>
            <a:stretch>
              <a:fillRect/>
            </a:stretch>
          </p:blipFill>
          <p:spPr>
            <a:xfrm>
              <a:off x="4657" y="953"/>
              <a:ext cx="1669" cy="6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图片 3" descr="20250428 NC ENTV-1 JSRV pAb-actin"/>
            <p:cNvPicPr>
              <a:picLocks noChangeAspect="1"/>
            </p:cNvPicPr>
            <p:nvPr/>
          </p:nvPicPr>
          <p:blipFill>
            <a:blip r:embed="rId14"/>
            <a:srcRect l="14336" t="28706" r="5619" b="62291"/>
            <a:stretch>
              <a:fillRect/>
            </a:stretch>
          </p:blipFill>
          <p:spPr>
            <a:xfrm>
              <a:off x="4657" y="1750"/>
              <a:ext cx="1668" cy="6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7" name="组合 6"/>
            <p:cNvGrpSpPr/>
            <p:nvPr>
              <p:custDataLst>
                <p:tags r:id="rId15"/>
              </p:custDataLst>
            </p:nvPr>
          </p:nvGrpSpPr>
          <p:grpSpPr>
            <a:xfrm rot="0">
              <a:off x="6336" y="842"/>
              <a:ext cx="1171" cy="488"/>
              <a:chOff x="2427" y="9008"/>
              <a:chExt cx="1171" cy="410"/>
            </a:xfrm>
          </p:grpSpPr>
          <p:cxnSp>
            <p:nvCxnSpPr>
              <p:cNvPr id="11" name="直接连接符 10"/>
              <p:cNvCxnSpPr/>
              <p:nvPr>
                <p:custDataLst>
                  <p:tags r:id="rId16"/>
                </p:custDataLst>
              </p:nvPr>
            </p:nvCxnSpPr>
            <p:spPr>
              <a:xfrm>
                <a:off x="2427" y="9170"/>
                <a:ext cx="19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sp>
            <p:nvSpPr>
              <p:cNvPr id="13" name="文本框 12"/>
              <p:cNvSpPr txBox="1"/>
              <p:nvPr>
                <p:custDataLst>
                  <p:tags r:id="rId17"/>
                </p:custDataLst>
              </p:nvPr>
            </p:nvSpPr>
            <p:spPr>
              <a:xfrm>
                <a:off x="2541" y="9008"/>
                <a:ext cx="1057" cy="41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900">
                    <a:latin typeface="Arial" panose="020B0604020202020204" pitchFamily="34" charset="0"/>
                    <a:cs typeface="Arial" panose="020B0604020202020204" pitchFamily="34" charset="0"/>
                  </a:rPr>
                  <a:t>80KDa</a:t>
                </a:r>
                <a:endParaRPr lang="en-US" altLang="zh-C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" name="组合 13"/>
            <p:cNvGrpSpPr/>
            <p:nvPr>
              <p:custDataLst>
                <p:tags r:id="rId18"/>
              </p:custDataLst>
            </p:nvPr>
          </p:nvGrpSpPr>
          <p:grpSpPr>
            <a:xfrm rot="0">
              <a:off x="6340" y="2049"/>
              <a:ext cx="1171" cy="410"/>
              <a:chOff x="2427" y="8980"/>
              <a:chExt cx="1171" cy="410"/>
            </a:xfrm>
          </p:grpSpPr>
          <p:cxnSp>
            <p:nvCxnSpPr>
              <p:cNvPr id="17" name="直接连接符 16"/>
              <p:cNvCxnSpPr/>
              <p:nvPr>
                <p:custDataLst>
                  <p:tags r:id="rId19"/>
                </p:custDataLst>
              </p:nvPr>
            </p:nvCxnSpPr>
            <p:spPr>
              <a:xfrm>
                <a:off x="2427" y="9170"/>
                <a:ext cx="19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sp>
            <p:nvSpPr>
              <p:cNvPr id="18" name="文本框 17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2541" y="8980"/>
                <a:ext cx="1057" cy="41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900">
                    <a:latin typeface="Arial" panose="020B0604020202020204" pitchFamily="34" charset="0"/>
                    <a:cs typeface="Arial" panose="020B0604020202020204" pitchFamily="34" charset="0"/>
                  </a:rPr>
                  <a:t>40KDa</a:t>
                </a:r>
                <a:endParaRPr lang="en-US" altLang="zh-C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" name="文本框 18"/>
            <p:cNvSpPr txBox="1"/>
            <p:nvPr>
              <p:custDataLst>
                <p:tags r:id="rId21"/>
              </p:custDataLst>
            </p:nvPr>
          </p:nvSpPr>
          <p:spPr>
            <a:xfrm>
              <a:off x="3676" y="1914"/>
              <a:ext cx="1137" cy="4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anti-actin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 rot="18780000">
              <a:off x="4675" y="442"/>
              <a:ext cx="738" cy="39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 rot="18780000">
              <a:off x="5061" y="96"/>
              <a:ext cx="1770" cy="45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ENTV-1-Gag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 rot="18780000">
              <a:off x="5695" y="203"/>
              <a:ext cx="1396" cy="38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JSRV-Gag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3714" y="1231"/>
              <a:ext cx="1042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pAb-p27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251460" y="1680210"/>
            <a:ext cx="4273550" cy="598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zh-CN" sz="800">
                <a:latin typeface="Arial" panose="020B0604020202020204" pitchFamily="34" charset="0"/>
                <a:cs typeface="Arial" panose="020B0604020202020204" pitchFamily="34" charset="0"/>
              </a:rPr>
              <a:t>Reactivity of 2C3 or pAb-p27 with eukaryotic ENTV-1 or JSRV Gag protein. HEK293T cells were transfected with pcDNA-ENTV-1-Gag, pcDNA-JSRV-Gag or empty vector (as a NC). The cells were lysed at 48 hpt for the detection of Gag using 2C3 (A) or pAb-p27 (B) as primary antibodies.</a:t>
            </a:r>
            <a:r>
              <a:rPr lang="en-US" altLang="zh-CN" sz="9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altLang="zh-CN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32715" y="22225"/>
            <a:ext cx="4298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2350770" y="22225"/>
            <a:ext cx="4298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10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11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12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13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14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15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16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17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2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3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4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5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6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7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8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ags/tag9.xml><?xml version="1.0" encoding="utf-8"?>
<p:tagLst xmlns:p="http://schemas.openxmlformats.org/presentationml/2006/main">
  <p:tag name="KSO_WM_DIAGRAM_VIRTUALLY_FRAME" val="{&quot;height&quot;:150.39246795415,&quot;left&quot;:0.9330919560635834,&quot;top&quot;:-22.062939145556243,&quot;width&quot;:174.72812630565517}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1</Words>
  <Application>WPS 演示</Application>
  <PresentationFormat>宽屏</PresentationFormat>
  <Paragraphs>3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novo</dc:creator>
  <cp:lastModifiedBy>，</cp:lastModifiedBy>
  <cp:revision>10</cp:revision>
  <dcterms:created xsi:type="dcterms:W3CDTF">2023-08-09T12:44:00Z</dcterms:created>
  <dcterms:modified xsi:type="dcterms:W3CDTF">2025-08-22T13:46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5EA871CEA3746219D2D96E7488109B7_13</vt:lpwstr>
  </property>
  <property fmtid="{D5CDD505-2E9C-101B-9397-08002B2CF9AE}" pid="3" name="KSOProductBuildVer">
    <vt:lpwstr>2052-12.1.0.22529</vt:lpwstr>
  </property>
</Properties>
</file>